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799263" cy="9929813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85082" autoAdjust="0"/>
  </p:normalViewPr>
  <p:slideViewPr>
    <p:cSldViewPr snapToGrid="0" showGuides="1">
      <p:cViewPr>
        <p:scale>
          <a:sx n="80" d="100"/>
          <a:sy n="80" d="100"/>
        </p:scale>
        <p:origin x="-1398" y="-72"/>
      </p:cViewPr>
      <p:guideLst>
        <p:guide orient="horz" pos="3120"/>
        <p:guide orient="horz" pos="1759"/>
        <p:guide orient="horz" pos="4481"/>
        <p:guide orient="horz" pos="397"/>
        <p:guide orient="horz" pos="5842"/>
        <p:guide pos="2160"/>
      </p:guideLst>
    </p:cSldViewPr>
  </p:slideViewPr>
  <p:notesTextViewPr>
    <p:cViewPr>
      <p:scale>
        <a:sx n="1" d="1"/>
        <a:sy n="1" d="1"/>
      </p:scale>
      <p:origin x="0" y="84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nalysed data'!$Z$96:$AQ$96</c:f>
                <c:numCache>
                  <c:formatCode>General</c:formatCode>
                  <c:ptCount val="18"/>
                  <c:pt idx="0">
                    <c:v>2.3777668017923408</c:v>
                  </c:pt>
                  <c:pt idx="1">
                    <c:v>1.8089265828771439</c:v>
                  </c:pt>
                  <c:pt idx="2">
                    <c:v>1.796127059988351</c:v>
                  </c:pt>
                  <c:pt idx="3">
                    <c:v>1.6908341009198213</c:v>
                  </c:pt>
                  <c:pt idx="4">
                    <c:v>2.6561326128527356</c:v>
                  </c:pt>
                  <c:pt idx="5">
                    <c:v>2.0356836574088972</c:v>
                  </c:pt>
                  <c:pt idx="6">
                    <c:v>2.5822117533790792</c:v>
                  </c:pt>
                  <c:pt idx="7">
                    <c:v>1.8894991879215639</c:v>
                  </c:pt>
                  <c:pt idx="8">
                    <c:v>3.7400656371075294</c:v>
                  </c:pt>
                  <c:pt idx="9">
                    <c:v>2.4274511093343021</c:v>
                  </c:pt>
                  <c:pt idx="10">
                    <c:v>2.4850250157647436</c:v>
                  </c:pt>
                  <c:pt idx="11">
                    <c:v>2.3880265529280829</c:v>
                  </c:pt>
                  <c:pt idx="12">
                    <c:v>3.960411837138897</c:v>
                  </c:pt>
                  <c:pt idx="13">
                    <c:v>3.11329517360921</c:v>
                  </c:pt>
                  <c:pt idx="14">
                    <c:v>2.740811007233515</c:v>
                  </c:pt>
                  <c:pt idx="15">
                    <c:v>2.1560492813162431</c:v>
                  </c:pt>
                  <c:pt idx="16">
                    <c:v>3.337129296205775</c:v>
                  </c:pt>
                  <c:pt idx="17">
                    <c:v>2.5925749026099258</c:v>
                  </c:pt>
                </c:numCache>
              </c:numRef>
            </c:plus>
            <c:minus>
              <c:numRef>
                <c:f>'Analysed data'!$Z$96:$AQ$96</c:f>
                <c:numCache>
                  <c:formatCode>General</c:formatCode>
                  <c:ptCount val="18"/>
                  <c:pt idx="0">
                    <c:v>2.3777668017923408</c:v>
                  </c:pt>
                  <c:pt idx="1">
                    <c:v>1.8089265828771439</c:v>
                  </c:pt>
                  <c:pt idx="2">
                    <c:v>1.796127059988351</c:v>
                  </c:pt>
                  <c:pt idx="3">
                    <c:v>1.6908341009198213</c:v>
                  </c:pt>
                  <c:pt idx="4">
                    <c:v>2.6561326128527356</c:v>
                  </c:pt>
                  <c:pt idx="5">
                    <c:v>2.0356836574088972</c:v>
                  </c:pt>
                  <c:pt idx="6">
                    <c:v>2.5822117533790792</c:v>
                  </c:pt>
                  <c:pt idx="7">
                    <c:v>1.8894991879215639</c:v>
                  </c:pt>
                  <c:pt idx="8">
                    <c:v>3.7400656371075294</c:v>
                  </c:pt>
                  <c:pt idx="9">
                    <c:v>2.4274511093343021</c:v>
                  </c:pt>
                  <c:pt idx="10">
                    <c:v>2.4850250157647436</c:v>
                  </c:pt>
                  <c:pt idx="11">
                    <c:v>2.3880265529280829</c:v>
                  </c:pt>
                  <c:pt idx="12">
                    <c:v>3.960411837138897</c:v>
                  </c:pt>
                  <c:pt idx="13">
                    <c:v>3.11329517360921</c:v>
                  </c:pt>
                  <c:pt idx="14">
                    <c:v>2.740811007233515</c:v>
                  </c:pt>
                  <c:pt idx="15">
                    <c:v>2.1560492813162431</c:v>
                  </c:pt>
                  <c:pt idx="16">
                    <c:v>3.337129296205775</c:v>
                  </c:pt>
                  <c:pt idx="17">
                    <c:v>2.5925749026099258</c:v>
                  </c:pt>
                </c:numCache>
              </c:numRef>
            </c:minus>
          </c:errBars>
          <c:val>
            <c:numRef>
              <c:f>'Analysed data'!$Z$95:$AQ$95</c:f>
              <c:numCache>
                <c:formatCode>0.00</c:formatCode>
                <c:ptCount val="18"/>
                <c:pt idx="0">
                  <c:v>77.975406249999992</c:v>
                </c:pt>
                <c:pt idx="1">
                  <c:v>83.149137499999995</c:v>
                </c:pt>
                <c:pt idx="2">
                  <c:v>81.59910625000002</c:v>
                </c:pt>
                <c:pt idx="3">
                  <c:v>78.166550000000001</c:v>
                </c:pt>
                <c:pt idx="4">
                  <c:v>87.236931249999998</c:v>
                </c:pt>
                <c:pt idx="5">
                  <c:v>99.586874999999992</c:v>
                </c:pt>
                <c:pt idx="6">
                  <c:v>109.29150625000001</c:v>
                </c:pt>
                <c:pt idx="7">
                  <c:v>115.95353750000001</c:v>
                </c:pt>
                <c:pt idx="8">
                  <c:v>108.32619374999999</c:v>
                </c:pt>
                <c:pt idx="9">
                  <c:v>116.46492500000001</c:v>
                </c:pt>
                <c:pt idx="10">
                  <c:v>106.06656875000002</c:v>
                </c:pt>
                <c:pt idx="11">
                  <c:v>106.25363750000002</c:v>
                </c:pt>
                <c:pt idx="12">
                  <c:v>110.90675</c:v>
                </c:pt>
                <c:pt idx="13">
                  <c:v>113.19468125</c:v>
                </c:pt>
                <c:pt idx="14">
                  <c:v>107.99560624999999</c:v>
                </c:pt>
                <c:pt idx="15">
                  <c:v>110.31443999999998</c:v>
                </c:pt>
                <c:pt idx="16">
                  <c:v>108.88462666666668</c:v>
                </c:pt>
                <c:pt idx="17">
                  <c:v>100.59791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0395520"/>
        <c:axId val="170401792"/>
      </c:lineChart>
      <c:catAx>
        <c:axId val="1703955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0401792"/>
        <c:crosses val="autoZero"/>
        <c:auto val="1"/>
        <c:lblAlgn val="ctr"/>
        <c:lblOffset val="100"/>
        <c:tickLblSkip val="2"/>
        <c:noMultiLvlLbl val="0"/>
      </c:catAx>
      <c:valAx>
        <c:axId val="1704017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Energy intake (kca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703955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nalysed data'!$Z$49:$AQ$49</c:f>
                <c:numCache>
                  <c:formatCode>General</c:formatCode>
                  <c:ptCount val="18"/>
                  <c:pt idx="0">
                    <c:v>1.7097310109341752</c:v>
                  </c:pt>
                  <c:pt idx="1">
                    <c:v>1.6482756994179293</c:v>
                  </c:pt>
                  <c:pt idx="2">
                    <c:v>1.4129369702524781</c:v>
                  </c:pt>
                  <c:pt idx="3">
                    <c:v>1.059205550458644</c:v>
                  </c:pt>
                  <c:pt idx="4">
                    <c:v>0.86651622262986427</c:v>
                  </c:pt>
                  <c:pt idx="5">
                    <c:v>0.14602099445941527</c:v>
                  </c:pt>
                  <c:pt idx="6">
                    <c:v>2.5237385823995134E-2</c:v>
                  </c:pt>
                  <c:pt idx="7">
                    <c:v>0.21313026941188573</c:v>
                  </c:pt>
                  <c:pt idx="8">
                    <c:v>0.10556048838620193</c:v>
                  </c:pt>
                  <c:pt idx="9">
                    <c:v>7.7685618826110484E-2</c:v>
                  </c:pt>
                  <c:pt idx="10">
                    <c:v>3.628608459031963E-2</c:v>
                  </c:pt>
                  <c:pt idx="11">
                    <c:v>9.5268365232444807E-2</c:v>
                  </c:pt>
                  <c:pt idx="12">
                    <c:v>0.33278357638010531</c:v>
                  </c:pt>
                  <c:pt idx="13">
                    <c:v>0.31767683569139255</c:v>
                  </c:pt>
                  <c:pt idx="14">
                    <c:v>0.22492662353879414</c:v>
                  </c:pt>
                  <c:pt idx="15">
                    <c:v>0.32883171550566054</c:v>
                  </c:pt>
                  <c:pt idx="16">
                    <c:v>8.7148993049736403E-2</c:v>
                  </c:pt>
                  <c:pt idx="17">
                    <c:v>0.3252088394361321</c:v>
                  </c:pt>
                </c:numCache>
              </c:numRef>
            </c:plus>
            <c:minus>
              <c:numRef>
                <c:f>'Analysed data'!$Z$49:$AQ$49</c:f>
                <c:numCache>
                  <c:formatCode>General</c:formatCode>
                  <c:ptCount val="18"/>
                  <c:pt idx="0">
                    <c:v>1.7097310109341752</c:v>
                  </c:pt>
                  <c:pt idx="1">
                    <c:v>1.6482756994179293</c:v>
                  </c:pt>
                  <c:pt idx="2">
                    <c:v>1.4129369702524781</c:v>
                  </c:pt>
                  <c:pt idx="3">
                    <c:v>1.059205550458644</c:v>
                  </c:pt>
                  <c:pt idx="4">
                    <c:v>0.86651622262986427</c:v>
                  </c:pt>
                  <c:pt idx="5">
                    <c:v>0.14602099445941527</c:v>
                  </c:pt>
                  <c:pt idx="6">
                    <c:v>2.5237385823995134E-2</c:v>
                  </c:pt>
                  <c:pt idx="7">
                    <c:v>0.21313026941188573</c:v>
                  </c:pt>
                  <c:pt idx="8">
                    <c:v>0.10556048838620193</c:v>
                  </c:pt>
                  <c:pt idx="9">
                    <c:v>7.7685618826110484E-2</c:v>
                  </c:pt>
                  <c:pt idx="10">
                    <c:v>3.628608459031963E-2</c:v>
                  </c:pt>
                  <c:pt idx="11">
                    <c:v>9.5268365232444807E-2</c:v>
                  </c:pt>
                  <c:pt idx="12">
                    <c:v>0.33278357638010531</c:v>
                  </c:pt>
                  <c:pt idx="13">
                    <c:v>0.31767683569139255</c:v>
                  </c:pt>
                  <c:pt idx="14">
                    <c:v>0.22492662353879414</c:v>
                  </c:pt>
                  <c:pt idx="15">
                    <c:v>0.32883171550566054</c:v>
                  </c:pt>
                  <c:pt idx="16">
                    <c:v>8.7148993049736403E-2</c:v>
                  </c:pt>
                  <c:pt idx="17">
                    <c:v>0.3252088394361321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val>
            <c:numRef>
              <c:f>'Analysed data'!$Z$48:$AQ$48</c:f>
              <c:numCache>
                <c:formatCode>0.00</c:formatCode>
                <c:ptCount val="18"/>
                <c:pt idx="0">
                  <c:v>8.5966500000000003</c:v>
                </c:pt>
                <c:pt idx="1">
                  <c:v>9.309825</c:v>
                </c:pt>
                <c:pt idx="2">
                  <c:v>9.6535625000000032</c:v>
                </c:pt>
                <c:pt idx="3">
                  <c:v>9.6134062499999917</c:v>
                </c:pt>
                <c:pt idx="4">
                  <c:v>3.4807437499999998</c:v>
                </c:pt>
                <c:pt idx="5">
                  <c:v>0.3887125000000014</c:v>
                </c:pt>
                <c:pt idx="6">
                  <c:v>9.476875000000283E-2</c:v>
                </c:pt>
                <c:pt idx="7">
                  <c:v>0.44653750000000131</c:v>
                </c:pt>
                <c:pt idx="8">
                  <c:v>0.30197499999999916</c:v>
                </c:pt>
                <c:pt idx="9">
                  <c:v>0.22969375000000106</c:v>
                </c:pt>
                <c:pt idx="10">
                  <c:v>0.12368124999999705</c:v>
                </c:pt>
                <c:pt idx="11">
                  <c:v>0.37425624999999996</c:v>
                </c:pt>
                <c:pt idx="12">
                  <c:v>0.71317499999999989</c:v>
                </c:pt>
                <c:pt idx="13">
                  <c:v>0.5605812499999997</c:v>
                </c:pt>
                <c:pt idx="14">
                  <c:v>0.62483125000000006</c:v>
                </c:pt>
                <c:pt idx="15">
                  <c:v>0.51239374999999965</c:v>
                </c:pt>
                <c:pt idx="16">
                  <c:v>0.27306249999999815</c:v>
                </c:pt>
                <c:pt idx="17">
                  <c:v>0.6794437499999984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1148032"/>
        <c:axId val="171149952"/>
      </c:lineChart>
      <c:catAx>
        <c:axId val="1711480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1149952"/>
        <c:crosses val="autoZero"/>
        <c:auto val="1"/>
        <c:lblAlgn val="ctr"/>
        <c:lblOffset val="100"/>
        <c:tickLblSkip val="2"/>
        <c:noMultiLvlLbl val="0"/>
      </c:catAx>
      <c:valAx>
        <c:axId val="171149952"/>
        <c:scaling>
          <c:orientation val="minMax"/>
          <c:max val="1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Energy intake (kca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711480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nalysed data'!$Z$72:$AQ$72</c:f>
                <c:numCache>
                  <c:formatCode>General</c:formatCode>
                  <c:ptCount val="18"/>
                  <c:pt idx="0">
                    <c:v>1.8721204480919753</c:v>
                  </c:pt>
                  <c:pt idx="1">
                    <c:v>1.9510104332301497</c:v>
                  </c:pt>
                  <c:pt idx="2">
                    <c:v>2.1325967376645347</c:v>
                  </c:pt>
                  <c:pt idx="3">
                    <c:v>1.9908944881419819</c:v>
                  </c:pt>
                  <c:pt idx="4">
                    <c:v>1.7965627768945045</c:v>
                  </c:pt>
                  <c:pt idx="5">
                    <c:v>2.7743492972057799</c:v>
                  </c:pt>
                  <c:pt idx="6">
                    <c:v>2.0401398521685259</c:v>
                  </c:pt>
                  <c:pt idx="7">
                    <c:v>2.04604862257922</c:v>
                  </c:pt>
                  <c:pt idx="8">
                    <c:v>1.964617457228611</c:v>
                  </c:pt>
                  <c:pt idx="9">
                    <c:v>2.5843385821048441</c:v>
                  </c:pt>
                  <c:pt idx="10">
                    <c:v>2.0373672298433512</c:v>
                  </c:pt>
                  <c:pt idx="11">
                    <c:v>2.2152544916248664</c:v>
                  </c:pt>
                  <c:pt idx="12">
                    <c:v>2.268089916445843</c:v>
                  </c:pt>
                  <c:pt idx="13">
                    <c:v>2.1045401097686467</c:v>
                  </c:pt>
                  <c:pt idx="14">
                    <c:v>1.7424990107481624</c:v>
                  </c:pt>
                  <c:pt idx="15">
                    <c:v>2.2619864926112987</c:v>
                  </c:pt>
                  <c:pt idx="16">
                    <c:v>1.6021876897438267</c:v>
                  </c:pt>
                  <c:pt idx="17">
                    <c:v>2.2351122976182407</c:v>
                  </c:pt>
                </c:numCache>
              </c:numRef>
            </c:plus>
            <c:minus>
              <c:numRef>
                <c:f>'Analysed data'!$Z$72:$AQ$72</c:f>
                <c:numCache>
                  <c:formatCode>General</c:formatCode>
                  <c:ptCount val="18"/>
                  <c:pt idx="0">
                    <c:v>1.8721204480919753</c:v>
                  </c:pt>
                  <c:pt idx="1">
                    <c:v>1.9510104332301497</c:v>
                  </c:pt>
                  <c:pt idx="2">
                    <c:v>2.1325967376645347</c:v>
                  </c:pt>
                  <c:pt idx="3">
                    <c:v>1.9908944881419819</c:v>
                  </c:pt>
                  <c:pt idx="4">
                    <c:v>1.7965627768945045</c:v>
                  </c:pt>
                  <c:pt idx="5">
                    <c:v>2.7743492972057799</c:v>
                  </c:pt>
                  <c:pt idx="6">
                    <c:v>2.0401398521685259</c:v>
                  </c:pt>
                  <c:pt idx="7">
                    <c:v>2.04604862257922</c:v>
                  </c:pt>
                  <c:pt idx="8">
                    <c:v>1.964617457228611</c:v>
                  </c:pt>
                  <c:pt idx="9">
                    <c:v>2.5843385821048441</c:v>
                  </c:pt>
                  <c:pt idx="10">
                    <c:v>2.0373672298433512</c:v>
                  </c:pt>
                  <c:pt idx="11">
                    <c:v>2.2152544916248664</c:v>
                  </c:pt>
                  <c:pt idx="12">
                    <c:v>2.268089916445843</c:v>
                  </c:pt>
                  <c:pt idx="13">
                    <c:v>2.1045401097686467</c:v>
                  </c:pt>
                  <c:pt idx="14">
                    <c:v>1.7424990107481624</c:v>
                  </c:pt>
                  <c:pt idx="15">
                    <c:v>2.2619864926112987</c:v>
                  </c:pt>
                  <c:pt idx="16">
                    <c:v>1.6021876897438267</c:v>
                  </c:pt>
                  <c:pt idx="17">
                    <c:v>2.2351122976182407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val>
            <c:numRef>
              <c:f>'Analysed data'!$Z$71:$AQ$71</c:f>
              <c:numCache>
                <c:formatCode>0.00</c:formatCode>
                <c:ptCount val="18"/>
                <c:pt idx="0">
                  <c:v>69.378756249999995</c:v>
                </c:pt>
                <c:pt idx="1">
                  <c:v>73.839312499999991</c:v>
                </c:pt>
                <c:pt idx="2">
                  <c:v>71.945543749999999</c:v>
                </c:pt>
                <c:pt idx="3">
                  <c:v>68.553143750000004</c:v>
                </c:pt>
                <c:pt idx="4">
                  <c:v>66.591912499999992</c:v>
                </c:pt>
                <c:pt idx="5">
                  <c:v>55.463812500000003</c:v>
                </c:pt>
                <c:pt idx="6">
                  <c:v>50.413762499999997</c:v>
                </c:pt>
                <c:pt idx="7">
                  <c:v>46.407774999999994</c:v>
                </c:pt>
                <c:pt idx="8">
                  <c:v>51.848143749999991</c:v>
                </c:pt>
                <c:pt idx="9">
                  <c:v>51.144606250000002</c:v>
                </c:pt>
                <c:pt idx="10">
                  <c:v>45.286612500000011</c:v>
                </c:pt>
                <c:pt idx="11">
                  <c:v>44.089956249999986</c:v>
                </c:pt>
                <c:pt idx="12">
                  <c:v>41.428399999999996</c:v>
                </c:pt>
                <c:pt idx="13">
                  <c:v>39.879974999999995</c:v>
                </c:pt>
                <c:pt idx="14">
                  <c:v>38.890524999999997</c:v>
                </c:pt>
                <c:pt idx="15">
                  <c:v>38.137086666666661</c:v>
                </c:pt>
                <c:pt idx="16">
                  <c:v>44.909893333333329</c:v>
                </c:pt>
                <c:pt idx="17">
                  <c:v>34.26837999999999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2158336"/>
        <c:axId val="173417984"/>
      </c:lineChart>
      <c:catAx>
        <c:axId val="1721583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73417984"/>
        <c:crosses val="autoZero"/>
        <c:auto val="1"/>
        <c:lblAlgn val="ctr"/>
        <c:lblOffset val="100"/>
        <c:tickLblSkip val="2"/>
        <c:noMultiLvlLbl val="0"/>
      </c:catAx>
      <c:valAx>
        <c:axId val="173417984"/>
        <c:scaling>
          <c:orientation val="minMax"/>
          <c:max val="9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Energy intake (kca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72158336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1"/>
          <c:order val="0"/>
          <c:tx>
            <c:strRef>
              <c:f>'Analysed data'!$AU$103</c:f>
              <c:strCache>
                <c:ptCount val="1"/>
                <c:pt idx="0">
                  <c:v>HF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mtClean="0"/>
                      <a:t>48,5%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mtClean="0"/>
                      <a:t>62,1%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Analysed data'!$AV$107:$AW$107</c:f>
                <c:numCache>
                  <c:formatCode>General</c:formatCode>
                  <c:ptCount val="2"/>
                  <c:pt idx="0">
                    <c:v>1.4753339954485851</c:v>
                  </c:pt>
                  <c:pt idx="1">
                    <c:v>1.2907072266427917</c:v>
                  </c:pt>
                </c:numCache>
              </c:numRef>
            </c:plus>
            <c:minus>
              <c:numRef>
                <c:f>'Analysed data'!$AV$107:$AW$107</c:f>
                <c:numCache>
                  <c:formatCode>General</c:formatCode>
                  <c:ptCount val="2"/>
                  <c:pt idx="0">
                    <c:v>1.4753339954485851</c:v>
                  </c:pt>
                  <c:pt idx="1">
                    <c:v>1.2907072266427917</c:v>
                  </c:pt>
                </c:numCache>
              </c:numRef>
            </c:minus>
          </c:errBars>
          <c:cat>
            <c:strRef>
              <c:f>'Analysed data'!$AV$101:$AW$101</c:f>
              <c:strCache>
                <c:ptCount val="2"/>
                <c:pt idx="0">
                  <c:v>week 1</c:v>
                </c:pt>
                <c:pt idx="1">
                  <c:v>week 2</c:v>
                </c:pt>
              </c:strCache>
            </c:strRef>
          </c:cat>
          <c:val>
            <c:numRef>
              <c:f>'Analysed data'!$AV$103:$AW$103</c:f>
              <c:numCache>
                <c:formatCode>0.00</c:formatCode>
                <c:ptCount val="2"/>
                <c:pt idx="0">
                  <c:v>48.465876623890978</c:v>
                </c:pt>
                <c:pt idx="1">
                  <c:v>62.057838121406675</c:v>
                </c:pt>
              </c:numCache>
            </c:numRef>
          </c:val>
        </c:ser>
        <c:ser>
          <c:idx val="0"/>
          <c:order val="1"/>
          <c:tx>
            <c:strRef>
              <c:f>'Analysed data'!$AU$102</c:f>
              <c:strCache>
                <c:ptCount val="1"/>
                <c:pt idx="0">
                  <c:v>Chow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nalysed data'!$AV$106:$AW$106</c:f>
                <c:numCache>
                  <c:formatCode>General</c:formatCode>
                  <c:ptCount val="2"/>
                  <c:pt idx="0">
                    <c:v>1.4753339954485543</c:v>
                  </c:pt>
                  <c:pt idx="1">
                    <c:v>1.2907072266427917</c:v>
                  </c:pt>
                </c:numCache>
              </c:numRef>
            </c:plus>
            <c:minus>
              <c:numRef>
                <c:f>'Analysed data'!$AV$106:$AW$106</c:f>
                <c:numCache>
                  <c:formatCode>General</c:formatCode>
                  <c:ptCount val="2"/>
                  <c:pt idx="0">
                    <c:v>1.4753339954485543</c:v>
                  </c:pt>
                  <c:pt idx="1">
                    <c:v>1.2907072266427917</c:v>
                  </c:pt>
                </c:numCache>
              </c:numRef>
            </c:minus>
          </c:errBars>
          <c:cat>
            <c:strRef>
              <c:f>'Analysed data'!$AV$101:$AW$101</c:f>
              <c:strCache>
                <c:ptCount val="2"/>
                <c:pt idx="0">
                  <c:v>week 1</c:v>
                </c:pt>
                <c:pt idx="1">
                  <c:v>week 2</c:v>
                </c:pt>
              </c:strCache>
            </c:strRef>
          </c:cat>
          <c:val>
            <c:numRef>
              <c:f>'Analysed data'!$AV$102:$AW$102</c:f>
              <c:numCache>
                <c:formatCode>0.00</c:formatCode>
                <c:ptCount val="2"/>
                <c:pt idx="0">
                  <c:v>51.534123376109029</c:v>
                </c:pt>
                <c:pt idx="1">
                  <c:v>37.9421618785933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2208128"/>
        <c:axId val="172209664"/>
      </c:barChart>
      <c:catAx>
        <c:axId val="172208128"/>
        <c:scaling>
          <c:orientation val="minMax"/>
        </c:scaling>
        <c:delete val="0"/>
        <c:axPos val="b"/>
        <c:majorTickMark val="out"/>
        <c:minorTickMark val="none"/>
        <c:tickLblPos val="nextTo"/>
        <c:crossAx val="172209664"/>
        <c:crosses val="autoZero"/>
        <c:auto val="1"/>
        <c:lblAlgn val="ctr"/>
        <c:lblOffset val="100"/>
        <c:noMultiLvlLbl val="0"/>
      </c:catAx>
      <c:valAx>
        <c:axId val="1722096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24h energy intak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722081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Analysed data'!$AU$151</c:f>
              <c:strCache>
                <c:ptCount val="1"/>
                <c:pt idx="0">
                  <c:v>HF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mtClean="0"/>
                      <a:t>96,2%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mtClean="0"/>
                      <a:t>99,2%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Analysed data'!$AV$106:$AW$106</c:f>
                <c:numCache>
                  <c:formatCode>General</c:formatCode>
                  <c:ptCount val="2"/>
                  <c:pt idx="0">
                    <c:v>1.4753339954485543</c:v>
                  </c:pt>
                  <c:pt idx="1">
                    <c:v>1.2907072266427917</c:v>
                  </c:pt>
                </c:numCache>
              </c:numRef>
            </c:plus>
            <c:minus>
              <c:numRef>
                <c:f>'Analysed data'!$AV$106:$AW$106</c:f>
                <c:numCache>
                  <c:formatCode>General</c:formatCode>
                  <c:ptCount val="2"/>
                  <c:pt idx="0">
                    <c:v>1.4753339954485543</c:v>
                  </c:pt>
                  <c:pt idx="1">
                    <c:v>1.2907072266427917</c:v>
                  </c:pt>
                </c:numCache>
              </c:numRef>
            </c:minus>
          </c:errBars>
          <c:cat>
            <c:strRef>
              <c:f>'Analysed data'!$AV$149:$AW$149</c:f>
              <c:strCache>
                <c:ptCount val="2"/>
                <c:pt idx="0">
                  <c:v>week 1</c:v>
                </c:pt>
                <c:pt idx="1">
                  <c:v>week 2</c:v>
                </c:pt>
              </c:strCache>
            </c:strRef>
          </c:cat>
          <c:val>
            <c:numRef>
              <c:f>'Analysed data'!$AV$151:$AW$151</c:f>
              <c:numCache>
                <c:formatCode>0.00</c:formatCode>
                <c:ptCount val="2"/>
                <c:pt idx="0">
                  <c:v>96.229352091465543</c:v>
                </c:pt>
                <c:pt idx="1">
                  <c:v>99.212830462828165</c:v>
                </c:pt>
              </c:numCache>
            </c:numRef>
          </c:val>
        </c:ser>
        <c:ser>
          <c:idx val="1"/>
          <c:order val="1"/>
          <c:tx>
            <c:strRef>
              <c:f>'Analysed data'!$AU$150</c:f>
              <c:strCache>
                <c:ptCount val="1"/>
                <c:pt idx="0">
                  <c:v>Chow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nalysed data'!$AV$107:$AW$107</c:f>
                <c:numCache>
                  <c:formatCode>General</c:formatCode>
                  <c:ptCount val="2"/>
                  <c:pt idx="0">
                    <c:v>1.4753339954485851</c:v>
                  </c:pt>
                  <c:pt idx="1">
                    <c:v>1.2907072266427917</c:v>
                  </c:pt>
                </c:numCache>
              </c:numRef>
            </c:plus>
            <c:minus>
              <c:numRef>
                <c:f>'Analysed data'!$AV$107:$AW$107</c:f>
                <c:numCache>
                  <c:formatCode>General</c:formatCode>
                  <c:ptCount val="2"/>
                  <c:pt idx="0">
                    <c:v>1.4753339954485851</c:v>
                  </c:pt>
                  <c:pt idx="1">
                    <c:v>1.2907072266427917</c:v>
                  </c:pt>
                </c:numCache>
              </c:numRef>
            </c:minus>
          </c:errBars>
          <c:cat>
            <c:strRef>
              <c:f>'Analysed data'!$AV$149:$AW$149</c:f>
              <c:strCache>
                <c:ptCount val="2"/>
                <c:pt idx="0">
                  <c:v>week 1</c:v>
                </c:pt>
                <c:pt idx="1">
                  <c:v>week 2</c:v>
                </c:pt>
              </c:strCache>
            </c:strRef>
          </c:cat>
          <c:val>
            <c:numRef>
              <c:f>'Analysed data'!$AV$150:$AW$150</c:f>
              <c:numCache>
                <c:formatCode>0.00</c:formatCode>
                <c:ptCount val="2"/>
                <c:pt idx="0">
                  <c:v>3.7706479085344462</c:v>
                </c:pt>
                <c:pt idx="1">
                  <c:v>0.787169537171834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4219648"/>
        <c:axId val="174221184"/>
      </c:barChart>
      <c:catAx>
        <c:axId val="174219648"/>
        <c:scaling>
          <c:orientation val="minMax"/>
        </c:scaling>
        <c:delete val="0"/>
        <c:axPos val="b"/>
        <c:majorTickMark val="out"/>
        <c:minorTickMark val="none"/>
        <c:tickLblPos val="nextTo"/>
        <c:crossAx val="174221184"/>
        <c:crosses val="autoZero"/>
        <c:auto val="1"/>
        <c:lblAlgn val="ctr"/>
        <c:lblOffset val="100"/>
        <c:noMultiLvlLbl val="0"/>
      </c:catAx>
      <c:valAx>
        <c:axId val="174221184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% of </a:t>
                </a:r>
                <a:r>
                  <a:rPr lang="en-US" dirty="0" smtClean="0"/>
                  <a:t>2h </a:t>
                </a:r>
                <a:r>
                  <a:rPr lang="en-US" dirty="0"/>
                  <a:t>energy intak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74219648"/>
        <c:crosses val="autoZero"/>
        <c:crossBetween val="between"/>
        <c:majorUnit val="20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nalysed data'!$Z$26:$AQ$26</c:f>
                <c:numCache>
                  <c:formatCode>General</c:formatCode>
                  <c:ptCount val="18"/>
                  <c:pt idx="4">
                    <c:v>2.9001280442350006</c:v>
                  </c:pt>
                  <c:pt idx="5">
                    <c:v>3.5505620148318253</c:v>
                  </c:pt>
                  <c:pt idx="6">
                    <c:v>3.2657338154374478</c:v>
                  </c:pt>
                  <c:pt idx="7">
                    <c:v>2.6607933625064537</c:v>
                  </c:pt>
                  <c:pt idx="8">
                    <c:v>4.276536332316728</c:v>
                  </c:pt>
                  <c:pt idx="9">
                    <c:v>2.9371248555843898</c:v>
                  </c:pt>
                  <c:pt idx="10">
                    <c:v>2.2966506580144772</c:v>
                  </c:pt>
                  <c:pt idx="11">
                    <c:v>3.0091519095294954</c:v>
                  </c:pt>
                  <c:pt idx="12">
                    <c:v>4.2073445443999207</c:v>
                  </c:pt>
                  <c:pt idx="13">
                    <c:v>1.9607624934257115</c:v>
                  </c:pt>
                  <c:pt idx="14">
                    <c:v>2.3461797671605087</c:v>
                  </c:pt>
                  <c:pt idx="15">
                    <c:v>2.8722617594270061</c:v>
                  </c:pt>
                  <c:pt idx="16">
                    <c:v>3.066316932840587</c:v>
                  </c:pt>
                  <c:pt idx="17">
                    <c:v>2.8512368934376657</c:v>
                  </c:pt>
                </c:numCache>
              </c:numRef>
            </c:plus>
            <c:minus>
              <c:numRef>
                <c:f>'Analysed data'!$Z$26:$AQ$26</c:f>
                <c:numCache>
                  <c:formatCode>General</c:formatCode>
                  <c:ptCount val="18"/>
                  <c:pt idx="4">
                    <c:v>2.9001280442350006</c:v>
                  </c:pt>
                  <c:pt idx="5">
                    <c:v>3.5505620148318253</c:v>
                  </c:pt>
                  <c:pt idx="6">
                    <c:v>3.2657338154374478</c:v>
                  </c:pt>
                  <c:pt idx="7">
                    <c:v>2.6607933625064537</c:v>
                  </c:pt>
                  <c:pt idx="8">
                    <c:v>4.276536332316728</c:v>
                  </c:pt>
                  <c:pt idx="9">
                    <c:v>2.9371248555843898</c:v>
                  </c:pt>
                  <c:pt idx="10">
                    <c:v>2.2966506580144772</c:v>
                  </c:pt>
                  <c:pt idx="11">
                    <c:v>3.0091519095294954</c:v>
                  </c:pt>
                  <c:pt idx="12">
                    <c:v>4.2073445443999207</c:v>
                  </c:pt>
                  <c:pt idx="13">
                    <c:v>1.9607624934257115</c:v>
                  </c:pt>
                  <c:pt idx="14">
                    <c:v>2.3461797671605087</c:v>
                  </c:pt>
                  <c:pt idx="15">
                    <c:v>2.8722617594270061</c:v>
                  </c:pt>
                  <c:pt idx="16">
                    <c:v>3.066316932840587</c:v>
                  </c:pt>
                  <c:pt idx="17">
                    <c:v>2.8512368934376657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cat>
            <c:numRef>
              <c:f>'Analysed data'!$Z$8:$AQ$8</c:f>
              <c:numCache>
                <c:formatCode>General</c:formatCode>
                <c:ptCount val="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</c:numCache>
            </c:numRef>
          </c:cat>
          <c:val>
            <c:numRef>
              <c:f>'Analysed data'!$Z$25:$AQ$25</c:f>
              <c:numCache>
                <c:formatCode>General</c:formatCode>
                <c:ptCount val="18"/>
                <c:pt idx="4" formatCode="0.00">
                  <c:v>17.164275000000004</c:v>
                </c:pt>
                <c:pt idx="5" formatCode="0.00">
                  <c:v>43.734350000000006</c:v>
                </c:pt>
                <c:pt idx="6" formatCode="0.00">
                  <c:v>58.782975000000008</c:v>
                </c:pt>
                <c:pt idx="7" formatCode="0.00">
                  <c:v>69.099225000000004</c:v>
                </c:pt>
                <c:pt idx="8" formatCode="0.00">
                  <c:v>56.176074999999997</c:v>
                </c:pt>
                <c:pt idx="9" formatCode="0.00">
                  <c:v>65.090625000000003</c:v>
                </c:pt>
                <c:pt idx="10" formatCode="0.00">
                  <c:v>60.656274999999994</c:v>
                </c:pt>
                <c:pt idx="11" formatCode="0.00">
                  <c:v>61.789425000000001</c:v>
                </c:pt>
                <c:pt idx="12" formatCode="0.00">
                  <c:v>68.765174999999985</c:v>
                </c:pt>
                <c:pt idx="13" formatCode="0.00">
                  <c:v>72.754125000000002</c:v>
                </c:pt>
                <c:pt idx="14" formatCode="0.00">
                  <c:v>68.480249999999998</c:v>
                </c:pt>
                <c:pt idx="15" formatCode="0.00">
                  <c:v>72.102400000000003</c:v>
                </c:pt>
                <c:pt idx="16" formatCode="0.00">
                  <c:v>63.440024999999999</c:v>
                </c:pt>
                <c:pt idx="17" formatCode="0.00">
                  <c:v>66.08294999999999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5188992"/>
        <c:axId val="175191168"/>
      </c:lineChart>
      <c:catAx>
        <c:axId val="175188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5191168"/>
        <c:crosses val="autoZero"/>
        <c:auto val="1"/>
        <c:lblAlgn val="ctr"/>
        <c:lblOffset val="100"/>
        <c:tickLblSkip val="2"/>
        <c:noMultiLvlLbl val="0"/>
      </c:catAx>
      <c:valAx>
        <c:axId val="1751911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Energy intake (kcal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751889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84</cdr:x>
      <cdr:y>0.1166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-631825"/>
          <a:ext cx="288036" cy="252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200" b="1" dirty="0" smtClean="0"/>
            <a:t>D</a:t>
          </a:r>
          <a:endParaRPr lang="en-GB" sz="1200" b="1" dirty="0"/>
        </a:p>
      </cdr:txBody>
    </cdr:sp>
  </cdr:relSizeAnchor>
  <cdr:relSizeAnchor xmlns:cdr="http://schemas.openxmlformats.org/drawingml/2006/chartDrawing">
    <cdr:from>
      <cdr:x>0.19151</cdr:x>
      <cdr:y>0</cdr:y>
    </cdr:from>
    <cdr:to>
      <cdr:x>0.58799</cdr:x>
      <cdr:y>0.14998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656688" y="0"/>
          <a:ext cx="1359536" cy="3240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400" b="1" dirty="0" smtClean="0"/>
            <a:t>24 hr-TOTAL</a:t>
          </a:r>
          <a:endParaRPr lang="en-GB" sz="14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.00325</cdr:y>
    </cdr:from>
    <cdr:to>
      <cdr:x>0.08421</cdr:x>
      <cdr:y>0.1197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7025"/>
          <a:ext cx="288036" cy="252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200" b="1" dirty="0" smtClean="0"/>
            <a:t>B</a:t>
          </a:r>
          <a:endParaRPr lang="en-GB" sz="1200" b="1" dirty="0"/>
        </a:p>
      </cdr:txBody>
    </cdr:sp>
  </cdr:relSizeAnchor>
  <cdr:relSizeAnchor xmlns:cdr="http://schemas.openxmlformats.org/drawingml/2006/chartDrawing">
    <cdr:from>
      <cdr:x>0.17094</cdr:x>
      <cdr:y>0.00122</cdr:y>
    </cdr:from>
    <cdr:to>
      <cdr:x>0.53682</cdr:x>
      <cdr:y>0.15101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84699" y="2639"/>
          <a:ext cx="1251505" cy="3240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400" b="1" dirty="0" smtClean="0"/>
            <a:t>2 hr-CHOW</a:t>
          </a:r>
          <a:endParaRPr lang="en-GB" sz="14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.00139</cdr:y>
    </cdr:from>
    <cdr:to>
      <cdr:x>0.08412</cdr:x>
      <cdr:y>0.1178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3012"/>
          <a:ext cx="288036" cy="252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200" b="1" dirty="0"/>
            <a:t>C</a:t>
          </a:r>
          <a:endParaRPr lang="en-GB" sz="1200" b="1" dirty="0"/>
        </a:p>
      </cdr:txBody>
    </cdr:sp>
  </cdr:relSizeAnchor>
  <cdr:relSizeAnchor xmlns:cdr="http://schemas.openxmlformats.org/drawingml/2006/chartDrawing">
    <cdr:from>
      <cdr:x>0.17076</cdr:x>
      <cdr:y>0.00328</cdr:y>
    </cdr:from>
    <cdr:to>
      <cdr:x>0.55982</cdr:x>
      <cdr:y>0.15305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84680" y="7097"/>
          <a:ext cx="1332152" cy="32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400" b="1" dirty="0" smtClean="0"/>
            <a:t>22 hr-CHOW</a:t>
          </a:r>
          <a:endParaRPr lang="en-GB" sz="1400" b="1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89</cdr:x>
      <cdr:y>0</cdr:y>
    </cdr:from>
    <cdr:to>
      <cdr:x>0.70336</cdr:x>
      <cdr:y>0.1496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48081" y="0"/>
          <a:ext cx="1763754" cy="3240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400" b="1" dirty="0" smtClean="0"/>
            <a:t>24 hr-PERCENTAGE</a:t>
          </a:r>
          <a:endParaRPr lang="en-GB" sz="1400" b="1" dirty="0"/>
        </a:p>
      </cdr:txBody>
    </cdr:sp>
  </cdr:relSizeAnchor>
  <cdr:relSizeAnchor xmlns:cdr="http://schemas.openxmlformats.org/drawingml/2006/chartDrawing">
    <cdr:from>
      <cdr:x>0</cdr:x>
      <cdr:y>0</cdr:y>
    </cdr:from>
    <cdr:to>
      <cdr:x>0.084</cdr:x>
      <cdr:y>0.11636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-3429000" y="-626480"/>
          <a:ext cx="288036" cy="252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200" b="1" dirty="0" smtClean="0"/>
            <a:t>F</a:t>
          </a:r>
          <a:endParaRPr lang="en-GB" sz="1200" b="1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89</cdr:x>
      <cdr:y>0.00288</cdr:y>
    </cdr:from>
    <cdr:to>
      <cdr:x>0.64049</cdr:x>
      <cdr:y>0.1528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48072" y="6217"/>
          <a:ext cx="1548172" cy="3240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400" b="1" dirty="0" smtClean="0"/>
            <a:t>2 hr-PERCENTAGE</a:t>
          </a:r>
          <a:endParaRPr lang="en-GB" sz="1400" b="1" dirty="0"/>
        </a:p>
      </cdr:txBody>
    </cdr:sp>
  </cdr:relSizeAnchor>
  <cdr:relSizeAnchor xmlns:cdr="http://schemas.openxmlformats.org/drawingml/2006/chartDrawing">
    <cdr:from>
      <cdr:x>0</cdr:x>
      <cdr:y>0</cdr:y>
    </cdr:from>
    <cdr:to>
      <cdr:x>0.084</cdr:x>
      <cdr:y>0.11665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0" y="0"/>
          <a:ext cx="288036" cy="252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200" b="1" dirty="0" smtClean="0"/>
            <a:t>E</a:t>
          </a:r>
          <a:endParaRPr lang="en-GB" sz="1200" b="1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4.84083E-5</cdr:x>
      <cdr:y>0.00253</cdr:y>
    </cdr:from>
    <cdr:to>
      <cdr:x>0.08404</cdr:x>
      <cdr:y>0.1191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66" y="5461"/>
          <a:ext cx="288036" cy="2520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200" b="1" dirty="0" smtClean="0"/>
            <a:t>A</a:t>
          </a:r>
          <a:endParaRPr lang="en-GB" sz="1200" b="1" dirty="0"/>
        </a:p>
      </cdr:txBody>
    </cdr:sp>
  </cdr:relSizeAnchor>
  <cdr:relSizeAnchor xmlns:cdr="http://schemas.openxmlformats.org/drawingml/2006/chartDrawing">
    <cdr:from>
      <cdr:x>0.17055</cdr:x>
      <cdr:y>0.00288</cdr:y>
    </cdr:from>
    <cdr:to>
      <cdr:x>0.46448</cdr:x>
      <cdr:y>0.15286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84844" y="6222"/>
          <a:ext cx="1007952" cy="3240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1400" b="1" dirty="0" smtClean="0"/>
            <a:t>2 hr-HFD</a:t>
          </a:r>
          <a:endParaRPr lang="en-GB" sz="1400" b="1" dirty="0"/>
        </a:p>
      </cdr:txBody>
    </cdr:sp>
  </cdr:relSizeAnchor>
  <cdr:relSizeAnchor xmlns:cdr="http://schemas.openxmlformats.org/drawingml/2006/chartDrawing">
    <cdr:from>
      <cdr:x>0.20787</cdr:x>
      <cdr:y>0.19622</cdr:y>
    </cdr:from>
    <cdr:to>
      <cdr:x>0.42362</cdr:x>
      <cdr:y>0.30002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712822" y="423961"/>
          <a:ext cx="739841" cy="2242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sv-SE" sz="1000" dirty="0" smtClean="0"/>
            <a:t>PSF start</a:t>
          </a:r>
          <a:endParaRPr lang="en-GB" sz="1000" dirty="0"/>
        </a:p>
      </cdr:txBody>
    </cdr:sp>
  </cdr:relSizeAnchor>
  <cdr:relSizeAnchor xmlns:cdr="http://schemas.openxmlformats.org/drawingml/2006/chartDrawing">
    <cdr:from>
      <cdr:x>0.36636</cdr:x>
      <cdr:y>0.30807</cdr:y>
    </cdr:from>
    <cdr:to>
      <cdr:x>0.36653</cdr:x>
      <cdr:y>0.46419</cdr:y>
    </cdr:to>
    <cdr:cxnSp macro="">
      <cdr:nvCxnSpPr>
        <cdr:cNvPr id="5" name="Straight Arrow Connector 4"/>
        <cdr:cNvCxnSpPr/>
      </cdr:nvCxnSpPr>
      <cdr:spPr>
        <a:xfrm xmlns:a="http://schemas.openxmlformats.org/drawingml/2006/main" flipH="1">
          <a:off x="1256304" y="665616"/>
          <a:ext cx="595" cy="337304"/>
        </a:xfrm>
        <a:prstGeom xmlns:a="http://schemas.openxmlformats.org/drawingml/2006/main" prst="straightConnector1">
          <a:avLst/>
        </a:prstGeom>
        <a:ln xmlns:a="http://schemas.openxmlformats.org/drawingml/2006/main" w="9525">
          <a:tailEnd type="arrow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934B9A-8FF2-42EB-A0EF-6A36D80A4E18}" type="datetimeFigureOut">
              <a:rPr lang="en-GB" smtClean="0"/>
              <a:t>13/10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9687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927" y="4716661"/>
            <a:ext cx="5439410" cy="446841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342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CDEBF9-BA5F-4860-8B0C-3C688DD56F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354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b="1" dirty="0" smtClean="0"/>
              <a:t>Fig.</a:t>
            </a:r>
            <a:r>
              <a:rPr lang="sv-SE" b="1" baseline="0" dirty="0" smtClean="0"/>
              <a:t> S1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sv-SE" baseline="0" dirty="0" err="1" smtClean="0"/>
              <a:t>Acclimatisation</a:t>
            </a:r>
            <a:r>
              <a:rPr lang="sv-SE" baseline="0" dirty="0" smtClean="0"/>
              <a:t> </a:t>
            </a:r>
            <a:r>
              <a:rPr lang="sv-SE" baseline="0" dirty="0" err="1" smtClean="0"/>
              <a:t>to</a:t>
            </a:r>
            <a:r>
              <a:rPr lang="sv-SE" baseline="0" dirty="0" smtClean="0"/>
              <a:t> </a:t>
            </a:r>
            <a:r>
              <a:rPr lang="sv-SE" baseline="0" dirty="0" err="1" smtClean="0"/>
              <a:t>scheduled</a:t>
            </a:r>
            <a:r>
              <a:rPr lang="sv-SE" baseline="0" dirty="0" smtClean="0"/>
              <a:t> </a:t>
            </a:r>
            <a:r>
              <a:rPr lang="sv-SE" baseline="0" dirty="0" err="1" smtClean="0"/>
              <a:t>feeding</a:t>
            </a:r>
            <a:r>
              <a:rPr lang="sv-SE" baseline="0" dirty="0" smtClean="0"/>
              <a:t>: (A) Energy </a:t>
            </a:r>
            <a:r>
              <a:rPr lang="sv-SE" baseline="0" dirty="0" err="1" smtClean="0"/>
              <a:t>intake</a:t>
            </a:r>
            <a:r>
              <a:rPr lang="sv-SE" baseline="0" dirty="0" smtClean="0"/>
              <a:t> from HFD in 2h-scheduled </a:t>
            </a:r>
            <a:r>
              <a:rPr lang="sv-SE" baseline="0" dirty="0" err="1" smtClean="0"/>
              <a:t>feeding</a:t>
            </a:r>
            <a:r>
              <a:rPr lang="sv-SE" baseline="0" dirty="0" smtClean="0"/>
              <a:t> </a:t>
            </a:r>
            <a:r>
              <a:rPr lang="sv-SE" baseline="0" dirty="0" err="1" smtClean="0"/>
              <a:t>time</a:t>
            </a:r>
            <a:r>
              <a:rPr lang="sv-SE" baseline="0" dirty="0" smtClean="0"/>
              <a:t>. (B) Energy </a:t>
            </a:r>
            <a:r>
              <a:rPr lang="sv-SE" baseline="0" dirty="0" err="1" smtClean="0"/>
              <a:t>intake</a:t>
            </a:r>
            <a:r>
              <a:rPr lang="sv-SE" baseline="0" dirty="0" smtClean="0"/>
              <a:t> from </a:t>
            </a:r>
            <a:r>
              <a:rPr lang="sv-SE" baseline="0" dirty="0" err="1" smtClean="0"/>
              <a:t>chow</a:t>
            </a:r>
            <a:r>
              <a:rPr lang="sv-SE" baseline="0" dirty="0" smtClean="0"/>
              <a:t> in 2h-scheduled </a:t>
            </a:r>
            <a:r>
              <a:rPr lang="sv-SE" baseline="0" dirty="0" err="1" smtClean="0"/>
              <a:t>feeding</a:t>
            </a:r>
            <a:r>
              <a:rPr lang="sv-SE" baseline="0" dirty="0" smtClean="0"/>
              <a:t> </a:t>
            </a:r>
            <a:r>
              <a:rPr lang="sv-SE" baseline="0" dirty="0" err="1" smtClean="0"/>
              <a:t>time</a:t>
            </a:r>
            <a:r>
              <a:rPr lang="sv-SE" baseline="0" dirty="0" smtClean="0"/>
              <a:t>. (C) Energy </a:t>
            </a:r>
            <a:r>
              <a:rPr lang="sv-SE" baseline="0" dirty="0" err="1" smtClean="0"/>
              <a:t>intake</a:t>
            </a:r>
            <a:r>
              <a:rPr lang="sv-SE" baseline="0" dirty="0" smtClean="0"/>
              <a:t> from </a:t>
            </a:r>
            <a:r>
              <a:rPr lang="sv-SE" baseline="0" dirty="0" err="1" smtClean="0"/>
              <a:t>chow</a:t>
            </a:r>
            <a:r>
              <a:rPr lang="sv-SE" baseline="0" dirty="0" smtClean="0"/>
              <a:t> in </a:t>
            </a:r>
            <a:r>
              <a:rPr lang="sv-SE" baseline="0" dirty="0" err="1" smtClean="0"/>
              <a:t>remaining</a:t>
            </a:r>
            <a:r>
              <a:rPr lang="sv-SE" baseline="0" dirty="0" smtClean="0"/>
              <a:t> 22h. (D) Total </a:t>
            </a:r>
            <a:r>
              <a:rPr lang="sv-SE" baseline="0" dirty="0" err="1" smtClean="0"/>
              <a:t>daily</a:t>
            </a:r>
            <a:r>
              <a:rPr lang="sv-SE" baseline="0" dirty="0" smtClean="0"/>
              <a:t> </a:t>
            </a:r>
            <a:r>
              <a:rPr lang="sv-SE" baseline="0" dirty="0" err="1" smtClean="0"/>
              <a:t>energy</a:t>
            </a:r>
            <a:r>
              <a:rPr lang="sv-SE" baseline="0" dirty="0" smtClean="0"/>
              <a:t> </a:t>
            </a:r>
            <a:r>
              <a:rPr lang="sv-SE" baseline="0" dirty="0" err="1" smtClean="0"/>
              <a:t>intake</a:t>
            </a:r>
            <a:r>
              <a:rPr lang="sv-SE" baseline="0" dirty="0" smtClean="0"/>
              <a:t>. (E)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centage of HFD in relation to chow within 2 h scheduled feeding. (F) Percentage of HFD in relation to chow within the</a:t>
            </a:r>
            <a:r>
              <a:rPr lang="en-GB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4 h day. Data are presented as mean ± sem. 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CDEBF9-BA5F-4860-8B0C-3C688DD56F6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4749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0509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2667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35999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6544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89007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87859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07295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16566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87921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46077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1211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F9E850-2D74-471D-B03F-F82EFAACB6E0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FAF72-B297-42A6-AFDA-1A42C52CE57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59308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-11064" y="620939"/>
            <a:ext cx="6869497" cy="6492649"/>
            <a:chOff x="-11064" y="620939"/>
            <a:chExt cx="6869497" cy="6492649"/>
          </a:xfrm>
        </p:grpSpPr>
        <p:sp>
          <p:nvSpPr>
            <p:cNvPr id="11" name="Rectangle 10"/>
            <p:cNvSpPr/>
            <p:nvPr/>
          </p:nvSpPr>
          <p:spPr>
            <a:xfrm>
              <a:off x="4691266" y="3016824"/>
              <a:ext cx="2020891" cy="133214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1200645" y="3024775"/>
              <a:ext cx="2085827" cy="133214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/>
            <p:cNvSpPr/>
            <p:nvPr/>
          </p:nvSpPr>
          <p:spPr>
            <a:xfrm>
              <a:off x="4611754" y="868646"/>
              <a:ext cx="2100404" cy="133214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200645" y="861370"/>
              <a:ext cx="2100404" cy="133214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86043967"/>
                </p:ext>
              </p:extLst>
            </p:nvPr>
          </p:nvGraphicFramePr>
          <p:xfrm>
            <a:off x="3429000" y="2782725"/>
            <a:ext cx="3429000" cy="21605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44200312"/>
                </p:ext>
              </p:extLst>
            </p:nvPr>
          </p:nvGraphicFramePr>
          <p:xfrm>
            <a:off x="3429000" y="629191"/>
            <a:ext cx="3420491" cy="21632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82763874"/>
                </p:ext>
              </p:extLst>
            </p:nvPr>
          </p:nvGraphicFramePr>
          <p:xfrm>
            <a:off x="0" y="2779237"/>
            <a:ext cx="3423985" cy="21635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94981594"/>
                </p:ext>
              </p:extLst>
            </p:nvPr>
          </p:nvGraphicFramePr>
          <p:xfrm>
            <a:off x="3429433" y="4937491"/>
            <a:ext cx="3429000" cy="21659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87513062"/>
                </p:ext>
              </p:extLst>
            </p:nvPr>
          </p:nvGraphicFramePr>
          <p:xfrm>
            <a:off x="-11064" y="4953001"/>
            <a:ext cx="3429000" cy="21605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49468854"/>
                </p:ext>
              </p:extLst>
            </p:nvPr>
          </p:nvGraphicFramePr>
          <p:xfrm>
            <a:off x="0" y="620939"/>
            <a:ext cx="3429166" cy="21605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282269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00</TotalTime>
  <Words>154</Words>
  <Application>Microsoft Office PowerPoint</Application>
  <PresentationFormat>A4 Paper (210x297 mm)</PresentationFormat>
  <Paragraphs>3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Gothen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a Bake</dc:creator>
  <cp:lastModifiedBy>Tina Bake</cp:lastModifiedBy>
  <cp:revision>157</cp:revision>
  <cp:lastPrinted>2016-05-12T10:39:45Z</cp:lastPrinted>
  <dcterms:created xsi:type="dcterms:W3CDTF">2013-12-04T15:37:02Z</dcterms:created>
  <dcterms:modified xsi:type="dcterms:W3CDTF">2016-10-13T10:27:39Z</dcterms:modified>
</cp:coreProperties>
</file>